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98" userDrawn="1">
          <p15:clr>
            <a:srgbClr val="A4A3A4"/>
          </p15:clr>
        </p15:guide>
        <p15:guide id="3" pos="7582" userDrawn="1">
          <p15:clr>
            <a:srgbClr val="A4A3A4"/>
          </p15:clr>
        </p15:guide>
        <p15:guide id="4" orient="horz" pos="3974" userDrawn="1">
          <p15:clr>
            <a:srgbClr val="A4A3A4"/>
          </p15:clr>
        </p15:guide>
        <p15:guide id="5" pos="1504" userDrawn="1">
          <p15:clr>
            <a:srgbClr val="A4A3A4"/>
          </p15:clr>
        </p15:guide>
        <p15:guide id="6" pos="1617" userDrawn="1">
          <p15:clr>
            <a:srgbClr val="A4A3A4"/>
          </p15:clr>
        </p15:guide>
        <p15:guide id="7" pos="3024" userDrawn="1">
          <p15:clr>
            <a:srgbClr val="A4A3A4"/>
          </p15:clr>
        </p15:guide>
        <p15:guide id="8" pos="3137" userDrawn="1">
          <p15:clr>
            <a:srgbClr val="A4A3A4"/>
          </p15:clr>
        </p15:guide>
        <p15:guide id="9" pos="4543" userDrawn="1">
          <p15:clr>
            <a:srgbClr val="A4A3A4"/>
          </p15:clr>
        </p15:guide>
        <p15:guide id="10" pos="4656" userDrawn="1">
          <p15:clr>
            <a:srgbClr val="A4A3A4"/>
          </p15:clr>
        </p15:guide>
        <p15:guide id="11" pos="6063" userDrawn="1">
          <p15:clr>
            <a:srgbClr val="A4A3A4"/>
          </p15:clr>
        </p15:guide>
        <p15:guide id="12" pos="6176" userDrawn="1">
          <p15:clr>
            <a:srgbClr val="A4A3A4"/>
          </p15:clr>
        </p15:guide>
        <p15:guide id="13" orient="horz" pos="3793" userDrawn="1">
          <p15:clr>
            <a:srgbClr val="A4A3A4"/>
          </p15:clr>
        </p15:guide>
        <p15:guide id="14" orient="horz" pos="1752" userDrawn="1">
          <p15:clr>
            <a:srgbClr val="A4A3A4"/>
          </p15:clr>
        </p15:guide>
        <p15:guide id="15" orient="horz" pos="23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59" autoAdjust="0"/>
    <p:restoredTop sz="94660"/>
  </p:normalViewPr>
  <p:slideViewPr>
    <p:cSldViewPr snapToGrid="0">
      <p:cViewPr varScale="1">
        <p:scale>
          <a:sx n="92" d="100"/>
          <a:sy n="92" d="100"/>
        </p:scale>
        <p:origin x="876" y="90"/>
      </p:cViewPr>
      <p:guideLst>
        <p:guide orient="horz" pos="346"/>
        <p:guide pos="98"/>
        <p:guide pos="7582"/>
        <p:guide orient="horz" pos="3974"/>
        <p:guide pos="1504"/>
        <p:guide pos="1617"/>
        <p:guide pos="3024"/>
        <p:guide pos="3137"/>
        <p:guide pos="4543"/>
        <p:guide pos="4656"/>
        <p:guide pos="6063"/>
        <p:guide pos="6176"/>
        <p:guide orient="horz" pos="3793"/>
        <p:guide orient="horz" pos="1752"/>
        <p:guide orient="horz" pos="23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4999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163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9752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7884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9481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048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859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0620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9151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1200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107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0A257-E577-4122-B8A5-B7EF6571DAD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26BD7D-2EC0-4DAB-ADE0-30C676A64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0958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615" y="254301"/>
            <a:ext cx="3281981" cy="26273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36671" y="461444"/>
            <a:ext cx="277144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  B  C  D  E  F G  H   I  J   K  L  M N  O  P  Q R  S  T  U  V W  X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39547" y="2908223"/>
            <a:ext cx="351190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: Blank; B: B80 (CC1); C: G37A (CC5); D: G52 (CC5); E: B164 (CC97); F: G160 (CC97); G: F9 (CC133); H: G13A (CC133); I: G9 (CC133); J: F68B (CC152); K: F62A (CC152); L: K11 (CC522); M: F33B (CC522); N: C3 (CC522); O: F60B (CC522); P: F37B (CC522); Q: C4 (CC522); R: K116 (CC522); S: B65 (CC522); T: G102 (CC522); U: G165B (CC522); V: Positive control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8325; W: Negative control mastermix </a:t>
            </a:r>
            <a:r>
              <a:rPr lang="de-DE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DNA; X: 100bp MWM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6344" y="254104"/>
            <a:ext cx="3282254" cy="2627517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0167" y="254105"/>
            <a:ext cx="3281983" cy="262749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8321" y="4064168"/>
            <a:ext cx="3290277" cy="2634264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1263535" y="0"/>
            <a:ext cx="806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lb1 + 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5650330" y="0"/>
            <a:ext cx="806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lb2 + 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9699654" y="-2017"/>
            <a:ext cx="806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lb3 + 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5706516" y="3825116"/>
            <a:ext cx="450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l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559676" y="531103"/>
            <a:ext cx="288798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  B  C  D  E  F  G H   I   J  K  L  M N  O  P  Q  R S  T  U  V  W X  Y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8854800" y="682193"/>
            <a:ext cx="2400633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 B C D E F G H  I  J  K L M N O P Q R S T U V W X Y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431988" y="4343404"/>
            <a:ext cx="305116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  B  C  D  E   F  G  H   I   J  K   L  M  N  O  P  Q  R  S  T   U  V  W  X  Y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220790" y="2908223"/>
            <a:ext cx="351190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: 100bp MWM; B: B80 (CC1); C: G37A (CC5); D: G52 (CC5); E: B164 (CC97); F: G160 (CC97); G: F9 (CC133); H: G13A (CC133); I: G9 (CC133); J: F68B (CC152); K: F62A (CC152); L: K11 (CC522); M: F33B (CC522); N: C3 (CC522); O: F60B (CC522); P: F37B (CC522); Q: C4 (CC522); R: K116 (CC522); S: B65 (CC522); T: G102 (CC522); U: G165B (CC522); V: Positive control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8325; W: Negative control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USA300; X: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gative control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astermix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NA; Y: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bp MWM</a:t>
            </a:r>
          </a:p>
        </p:txBody>
      </p:sp>
      <p:sp>
        <p:nvSpPr>
          <p:cNvPr id="21" name="Rechteck 20"/>
          <p:cNvSpPr/>
          <p:nvPr/>
        </p:nvSpPr>
        <p:spPr>
          <a:xfrm>
            <a:off x="8438209" y="2908223"/>
            <a:ext cx="364369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: 100bp </a:t>
            </a:r>
            <a:r>
              <a:rPr lang="de-DE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WM; </a:t>
            </a:r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: B80 (CC1); C: G37A (CC5); D: G52 (CC5); E: B164 (CC97); F: G160 (CC97); G: F9 (CC133); H: G13A (CC133); I: G9 (</a:t>
            </a:r>
            <a:r>
              <a:rPr lang="de-DE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133); </a:t>
            </a:r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: F68B (CC152); K: </a:t>
            </a:r>
            <a:r>
              <a:rPr lang="de-DE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62A </a:t>
            </a:r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C152); L: K11 (CC522); M: F33B (CC522); N: C3 (CC522); O: F60B (CC522); P: F37B (CC522); Q: C4 (CC522); R: K116 (CC522); S: B65 (CC522); T: G102 (CC522); U: G165B (CC522); V: Positive control </a:t>
            </a:r>
            <a:r>
              <a:rPr lang="de-DE" sz="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8325; W: Negative control </a:t>
            </a:r>
            <a:r>
              <a:rPr lang="de-DE" sz="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USA300; X: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egative control </a:t>
            </a:r>
            <a:r>
              <a:rPr lang="en-US" sz="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stermix</a:t>
            </a:r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thout DNA; Y: </a:t>
            </a:r>
            <a:r>
              <a:rPr lang="de-DE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 </a:t>
            </a:r>
            <a:r>
              <a:rPr lang="de-DE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WM</a:t>
            </a:r>
            <a:endParaRPr lang="de-DE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7808743" y="4842691"/>
            <a:ext cx="351190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: 100bp MWM; B: B80 (CC1); C: G37A (CC5); D: G52 (CC5); E: B164 (CC97); F: G160 (CC97); G: F9 (CC133); H: G13A (CC133); I: G9 (CC133); J: F68B (CC152); K: F62A (CC152); L: K11 (CC522); M: F33B (CC522); N: C3 (CC522); O: F60B (CC522); P: F37B (CC522); Q: C4 (CC522); R: K116 (CC522); S: B65 (CC522); T: G102 (CC522); U: G165B (CC522); V: Positive control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8325; W: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reus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USA300; X: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gative control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astermix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NA; Y: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bp MWM</a:t>
            </a:r>
          </a:p>
        </p:txBody>
      </p:sp>
      <p:cxnSp>
        <p:nvCxnSpPr>
          <p:cNvPr id="3" name="Gerader Verbinder 2"/>
          <p:cNvCxnSpPr>
            <a:stCxn id="5" idx="2"/>
          </p:cNvCxnSpPr>
          <p:nvPr/>
        </p:nvCxnSpPr>
        <p:spPr>
          <a:xfrm flipH="1">
            <a:off x="1621133" y="661499"/>
            <a:ext cx="1263" cy="1971375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/>
          <p:cNvCxnSpPr/>
          <p:nvPr/>
        </p:nvCxnSpPr>
        <p:spPr>
          <a:xfrm>
            <a:off x="2593571" y="661499"/>
            <a:ext cx="408" cy="195701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 rot="-5340000">
            <a:off x="1799682" y="2138012"/>
            <a:ext cx="62958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52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r Verbinder 24"/>
          <p:cNvCxnSpPr/>
          <p:nvPr/>
        </p:nvCxnSpPr>
        <p:spPr>
          <a:xfrm>
            <a:off x="5924286" y="733201"/>
            <a:ext cx="1719" cy="1995535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r Verbinder 25"/>
          <p:cNvCxnSpPr/>
          <p:nvPr/>
        </p:nvCxnSpPr>
        <p:spPr>
          <a:xfrm>
            <a:off x="6914264" y="727857"/>
            <a:ext cx="1720" cy="1979362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 rot="-5400000">
            <a:off x="6168769" y="2229638"/>
            <a:ext cx="57946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52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Gerader Verbinder 27"/>
          <p:cNvCxnSpPr/>
          <p:nvPr/>
        </p:nvCxnSpPr>
        <p:spPr>
          <a:xfrm flipH="1">
            <a:off x="9998614" y="882248"/>
            <a:ext cx="39877" cy="182497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 rot="-5400000">
            <a:off x="10101827" y="2197504"/>
            <a:ext cx="62958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52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Gerader Verbinder 30"/>
          <p:cNvCxnSpPr/>
          <p:nvPr/>
        </p:nvCxnSpPr>
        <p:spPr>
          <a:xfrm flipH="1">
            <a:off x="5866222" y="4542413"/>
            <a:ext cx="16207" cy="2058083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r Verbinder 32"/>
          <p:cNvCxnSpPr/>
          <p:nvPr/>
        </p:nvCxnSpPr>
        <p:spPr>
          <a:xfrm>
            <a:off x="6914264" y="4542413"/>
            <a:ext cx="11596" cy="2058083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 rot="-5400000">
            <a:off x="6143709" y="6162591"/>
            <a:ext cx="62958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52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Gerader Verbinder 31"/>
          <p:cNvCxnSpPr/>
          <p:nvPr/>
        </p:nvCxnSpPr>
        <p:spPr>
          <a:xfrm>
            <a:off x="5591786" y="731158"/>
            <a:ext cx="0" cy="197606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34"/>
          <p:cNvSpPr txBox="1"/>
          <p:nvPr/>
        </p:nvSpPr>
        <p:spPr>
          <a:xfrm rot="-5400000">
            <a:off x="5477897" y="2229637"/>
            <a:ext cx="57946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15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Gerader Verbinder 41"/>
          <p:cNvCxnSpPr/>
          <p:nvPr/>
        </p:nvCxnSpPr>
        <p:spPr>
          <a:xfrm flipH="1">
            <a:off x="10796649" y="882247"/>
            <a:ext cx="39877" cy="182497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348056" y="4216581"/>
            <a:ext cx="3751281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 PCR detection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b="1" i="1" dirty="0" err="1">
                <a:latin typeface="Arial" panose="020B0604020202020204" pitchFamily="34" charset="0"/>
                <a:cs typeface="Arial" panose="020B0604020202020204" pitchFamily="34" charset="0"/>
              </a:rPr>
              <a:t>hl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b="1" i="1" dirty="0" err="1">
                <a:latin typeface="Arial" panose="020B0604020202020204" pitchFamily="34" charset="0"/>
                <a:cs typeface="Arial" panose="020B0604020202020204" pitchFamily="34" charset="0"/>
              </a:rPr>
              <a:t>hlb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S. aureu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isolates representing various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Cs</a:t>
            </a: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ene and gene product: </a:t>
            </a:r>
            <a:r>
              <a:rPr lang="en-US" b="1" i="1" dirty="0" err="1">
                <a:latin typeface="Arial" panose="020B0604020202020204" pitchFamily="34" charset="0"/>
                <a:cs typeface="Arial" panose="020B0604020202020204" pitchFamily="34" charset="0"/>
              </a:rPr>
              <a:t>hl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: 201bp; </a:t>
            </a:r>
            <a:r>
              <a:rPr lang="en-US" b="1" i="1" dirty="0" err="1">
                <a:latin typeface="Arial" panose="020B0604020202020204" pitchFamily="34" charset="0"/>
                <a:cs typeface="Arial" panose="020B0604020202020204" pitchFamily="34" charset="0"/>
              </a:rPr>
              <a:t>hlb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1+2: 534bp; </a:t>
            </a:r>
            <a:r>
              <a:rPr lang="en-US" b="1" i="1" dirty="0" err="1">
                <a:latin typeface="Arial" panose="020B0604020202020204" pitchFamily="34" charset="0"/>
                <a:cs typeface="Arial" panose="020B0604020202020204" pitchFamily="34" charset="0"/>
              </a:rPr>
              <a:t>hlb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2+3: 900bp; </a:t>
            </a:r>
            <a:r>
              <a:rPr lang="en-US" b="1" i="1" dirty="0" err="1">
                <a:latin typeface="Arial" panose="020B0604020202020204" pitchFamily="34" charset="0"/>
                <a:cs typeface="Arial" panose="020B0604020202020204" pitchFamily="34" charset="0"/>
              </a:rPr>
              <a:t>hlb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3+4: 140bp</a:t>
            </a:r>
          </a:p>
        </p:txBody>
      </p:sp>
    </p:spTree>
    <p:extLst>
      <p:ext uri="{BB962C8B-B14F-4D97-AF65-F5344CB8AC3E}">
        <p14:creationId xmlns:p14="http://schemas.microsoft.com/office/powerpoint/2010/main" val="232691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</TotalTime>
  <Words>76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GGC OMUARAN</dc:creator>
  <cp:lastModifiedBy>Adebayo Shittu</cp:lastModifiedBy>
  <cp:revision>77</cp:revision>
  <cp:lastPrinted>2021-03-22T11:59:46Z</cp:lastPrinted>
  <dcterms:created xsi:type="dcterms:W3CDTF">2021-01-12T14:21:56Z</dcterms:created>
  <dcterms:modified xsi:type="dcterms:W3CDTF">2021-08-15T23:12:41Z</dcterms:modified>
</cp:coreProperties>
</file>